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Editor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1" autoAdjust="0"/>
    <p:restoredTop sz="94660"/>
  </p:normalViewPr>
  <p:slideViewPr>
    <p:cSldViewPr snapToGrid="0">
      <p:cViewPr varScale="1">
        <p:scale>
          <a:sx n="81" d="100"/>
          <a:sy n="81" d="100"/>
        </p:scale>
        <p:origin x="82" y="17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7536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6558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289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9037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0687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0041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709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1723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24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034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8377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CAF04-A009-4CA4-96C4-5C466454E885}" type="datetimeFigureOut">
              <a:rPr lang="ko-KR" altLang="en-US" smtClean="0"/>
              <a:t>2023-12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F461D-81C5-4D16-B64C-FAB89DD9031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010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DE935924-41AA-498C-9A11-8224AEDC5D4F}"/>
              </a:ext>
            </a:extLst>
          </p:cNvPr>
          <p:cNvSpPr txBox="1"/>
          <p:nvPr/>
        </p:nvSpPr>
        <p:spPr>
          <a:xfrm>
            <a:off x="8072011" y="2879773"/>
            <a:ext cx="13689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. Age ratio</a:t>
            </a:r>
            <a:endParaRPr lang="en-US" sz="16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935924-41AA-498C-9A11-8224AEDC5D4F}"/>
              </a:ext>
            </a:extLst>
          </p:cNvPr>
          <p:cNvSpPr txBox="1"/>
          <p:nvPr/>
        </p:nvSpPr>
        <p:spPr>
          <a:xfrm>
            <a:off x="7509866" y="413137"/>
            <a:ext cx="28769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. Male to female </a:t>
            </a:r>
            <a:r>
              <a:rPr lang="en-US" sz="1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ati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E935924-41AA-498C-9A11-8224AEDC5D4F}"/>
              </a:ext>
            </a:extLst>
          </p:cNvPr>
          <p:cNvSpPr txBox="1"/>
          <p:nvPr/>
        </p:nvSpPr>
        <p:spPr>
          <a:xfrm>
            <a:off x="1117513" y="413137"/>
            <a:ext cx="5057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. Prevalence of </a:t>
            </a:r>
            <a:r>
              <a:rPr lang="en-US" sz="1600" b="1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mpylobacter </a:t>
            </a:r>
            <a:r>
              <a:rPr lang="en-US" sz="1600" b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olated in six provinces</a:t>
            </a:r>
            <a:endParaRPr lang="en-US" sz="1600" b="1" dirty="0">
              <a:solidFill>
                <a:schemeClr val="tx1">
                  <a:lumMod val="75000"/>
                  <a:lumOff val="25000"/>
                </a:schemeClr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3089" y="1197291"/>
            <a:ext cx="3241397" cy="4739522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7863" y="1093587"/>
            <a:ext cx="3175837" cy="1483931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64712" y="3355346"/>
            <a:ext cx="4147832" cy="29683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08024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1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2" fill="hold">
                            <p:stCondLst>
                              <p:cond delay="1000"/>
                            </p:stCondLst>
                            <p:childTnLst>
                              <p:par>
                                <p:cTn id="13" presetID="22" presetClass="entr" presetSubtype="8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" grpId="0"/>
      <p:bldP spid="17" grpId="0"/>
      <p:bldP spid="19" grpId="0"/>
    </p:bld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1</TotalTime>
  <Words>19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im So Yeon</dc:creator>
  <cp:lastModifiedBy>Kim So Yeon</cp:lastModifiedBy>
  <cp:revision>22</cp:revision>
  <dcterms:created xsi:type="dcterms:W3CDTF">2023-12-09T09:26:31Z</dcterms:created>
  <dcterms:modified xsi:type="dcterms:W3CDTF">2023-12-18T15:27:57Z</dcterms:modified>
</cp:coreProperties>
</file>